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03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9896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25705"/>
            <a:ext cx="80648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atter-</a:t>
            </a:r>
            <a:r>
              <a:rPr lang="en-GB" dirty="0" err="1"/>
              <a:t>Rieck</a:t>
            </a:r>
            <a:r>
              <a:rPr lang="en-GB" dirty="0"/>
              <a:t> et al (2023) Diabetologia DOI 10.1007/s00125-023-05901-y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n overview of climate change adaptation and mitigation strategies for people with diabetes, clinicians, public-health professionals and policy stakeholder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832F836-D8BB-A226-0A1C-111A3F4998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8370" y="1340768"/>
            <a:ext cx="4787260" cy="4382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25705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atter-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ieck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3-05901-y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n overview of climate-change-associated health risks and consequences for people with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9901024-C6A2-BD0E-102F-2CD1D5E531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7664" y="1210649"/>
            <a:ext cx="6107776" cy="4463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8390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1</cp:revision>
  <dcterms:created xsi:type="dcterms:W3CDTF">2016-06-15T12:53:43Z</dcterms:created>
  <dcterms:modified xsi:type="dcterms:W3CDTF">2023-03-20T11:49:56Z</dcterms:modified>
</cp:coreProperties>
</file>